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6161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6789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8527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1316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387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800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4395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370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220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7236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1010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62557-CFD8-425E-BBDB-E60495BE6DEE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8E693-1BE4-4AD8-A7E3-F387AF0087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6922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9020089"/>
              </p:ext>
            </p:extLst>
          </p:nvPr>
        </p:nvGraphicFramePr>
        <p:xfrm>
          <a:off x="832511" y="788487"/>
          <a:ext cx="5076969" cy="81521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35981">
                  <a:extLst>
                    <a:ext uri="{9D8B030D-6E8A-4147-A177-3AD203B41FA5}">
                      <a16:colId xmlns:a16="http://schemas.microsoft.com/office/drawing/2014/main" xmlns="" val="3130959745"/>
                    </a:ext>
                  </a:extLst>
                </a:gridCol>
                <a:gridCol w="2740988">
                  <a:extLst>
                    <a:ext uri="{9D8B030D-6E8A-4147-A177-3AD203B41FA5}">
                      <a16:colId xmlns:a16="http://schemas.microsoft.com/office/drawing/2014/main" xmlns="" val="3233278776"/>
                    </a:ext>
                  </a:extLst>
                </a:gridCol>
              </a:tblGrid>
              <a:tr h="116913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n-GB" sz="12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42" marR="42442" marT="589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 </a:t>
                      </a:r>
                      <a:r>
                        <a:rPr lang="de-DE" sz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(5′→3′)</a:t>
                      </a:r>
                      <a:endParaRPr lang="en-GB" sz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442" marR="42442" marT="5895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06707923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_f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_r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TTATTCCCTGCTTGCTT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TGATCTTCTTGATGGTTCC</a:t>
                      </a:r>
                      <a:endParaRPr lang="en-GB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458243713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2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2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GGA GATCAAGGAAGAG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CATCAGCGGAACAAA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9189674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3_f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_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AAGGCCGGAAAGGAAA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GAGCAGATTGACACC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36317881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4_f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4_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CTTCTTTTCTTGTGTCACT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TCCTACGCCTCCATCT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56958639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5_f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5_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TTCAACTTCTCAAACACC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CCTACGCCTCCGTCT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9512433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6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6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TATCATTTCCCAGTTTGTAAG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TCAACGATTTCAGCAC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43957880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TCTTCTCATCTTAAGCTTG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TCCAACACCTCCATCAC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26441778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8_f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8_r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AATCTTCCCATTTTTAGCT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ATTCGCTCCCTTCACCA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00537122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9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09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GTCTGTTCTTTGATCAATT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CATCGAGAACAAATG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98140232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0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0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CTTATGGAGACCTAGCTATT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GGGGTGCTTTCTTTGA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9899667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1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1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CTTCAGCTCTTCTACATT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CGATTTCAGCGCTCTT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27374729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2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2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CTGATCATTTCCCTTTTAG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CTCCTCCATCACCTT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9860513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3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3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GTTTACCTCATCAAATTATTAACT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CCGAGGTTGATCTTC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62905001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4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4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ACCTCATCAGTCACACC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CGCCAAAGGTGATCTT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67569630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5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5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GTGTCATTTCCCAACTCA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TTTCAGCACCCTTGAC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8937960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6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6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ATTGAGAATTTCGATCCT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TGCCTTCCCCAAAGGT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4988582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7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7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TCTTCAAGTACGAGGCTGA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TGGCATCAATTCTGTGC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06398645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8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8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AAGCTAGCTGAGCCAA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CTTCCAGGAATTCGA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97962594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9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19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GTCAATTTCATCAGCA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ATGGCCTGAGGCATGAG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957187079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20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20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CAGAATCGATGAACTC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TCTCCAATGGGGTTGTA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47101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21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.21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GAGGTGATTAACACATAGATTAC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GCACTAGCCATGAATGT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51487148"/>
                  </a:ext>
                </a:extLst>
              </a:tr>
              <a:tr h="25842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spacer_f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spacer_r</a:t>
                      </a:r>
                      <a:endParaRPr lang="en-GB" sz="10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GTTGATTCGCACAATTGGTCATC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de-DE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TGCGGGTCGGCAATCGGA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</a:t>
                      </a:r>
                      <a:endParaRPr lang="en-GB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6590" marR="56590" marT="28295" marB="28295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31319737"/>
                  </a:ext>
                </a:extLst>
              </a:tr>
            </a:tbl>
          </a:graphicData>
        </a:graphic>
      </p:graphicFrame>
      <p:sp>
        <p:nvSpPr>
          <p:cNvPr id="9" name="Rechteck 8"/>
          <p:cNvSpPr/>
          <p:nvPr/>
        </p:nvSpPr>
        <p:spPr>
          <a:xfrm>
            <a:off x="798004" y="436262"/>
            <a:ext cx="5076969" cy="2802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3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imers of the 21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-10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forms used for qPCR analysis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8852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1</Words>
  <Application>Microsoft Office PowerPoint</Application>
  <PresentationFormat>On-screen Show (4:3)</PresentationFormat>
  <Paragraphs>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lfried Schwab</dc:creator>
  <cp:lastModifiedBy>mhahca</cp:lastModifiedBy>
  <cp:revision>3</cp:revision>
  <dcterms:created xsi:type="dcterms:W3CDTF">2018-08-06T08:33:56Z</dcterms:created>
  <dcterms:modified xsi:type="dcterms:W3CDTF">2019-01-10T13:59:45Z</dcterms:modified>
</cp:coreProperties>
</file>